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18" r:id="rId2"/>
    <p:sldId id="29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818A"/>
    <a:srgbClr val="FC6C76"/>
    <a:srgbClr val="FECCCD"/>
    <a:srgbClr val="DDCDFD"/>
    <a:srgbClr val="FECC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405" autoAdjust="0"/>
    <p:restoredTop sz="94364" autoAdjust="0"/>
  </p:normalViewPr>
  <p:slideViewPr>
    <p:cSldViewPr snapToGrid="0">
      <p:cViewPr varScale="1">
        <p:scale>
          <a:sx n="114" d="100"/>
          <a:sy n="114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033333-F67B-414B-AF29-38527C80EB89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189F5D-ABF9-4B9E-8E13-67334274E8AE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96091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189F5D-ABF9-4B9E-8E13-67334274E8AE}" type="slidenum">
              <a:rPr lang="fr-BE" smtClean="0"/>
              <a:t>1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878702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16783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8517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41374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80102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43145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26069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70460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649210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55931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92164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48380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12BAD-9588-44BA-AE4E-0AAEC9C968A8}" type="datetimeFigureOut">
              <a:rPr lang="fr-BE" smtClean="0"/>
              <a:t>3/03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285058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4433762"/>
              </p:ext>
            </p:extLst>
          </p:nvPr>
        </p:nvGraphicFramePr>
        <p:xfrm>
          <a:off x="505201" y="293614"/>
          <a:ext cx="7959287" cy="5277784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137041"/>
                <a:gridCol w="1137041"/>
                <a:gridCol w="1137041"/>
                <a:gridCol w="1137041"/>
                <a:gridCol w="1137041"/>
                <a:gridCol w="1137041"/>
                <a:gridCol w="1137041"/>
              </a:tblGrid>
              <a:tr h="219136">
                <a:tc>
                  <a:txBody>
                    <a:bodyPr/>
                    <a:lstStyle/>
                    <a:p>
                      <a:pPr algn="ctr"/>
                      <a:endParaRPr lang="fr-BE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BE" sz="110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fr-BE" sz="11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BE" sz="110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h</a:t>
                      </a:r>
                      <a:endParaRPr lang="fr-BE" sz="11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BE" sz="110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h</a:t>
                      </a:r>
                      <a:endParaRPr lang="fr-BE" sz="11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dirty="0"/>
                    </a:p>
                  </a:txBody>
                  <a:tcPr/>
                </a:tc>
              </a:tr>
              <a:tr h="528354">
                <a:tc>
                  <a:txBody>
                    <a:bodyPr/>
                    <a:lstStyle/>
                    <a:p>
                      <a:pPr algn="ctr"/>
                      <a:endParaRPr lang="fr-BE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r>
                        <a:rPr lang="fr-BE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BE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BSO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r>
                        <a:rPr lang="fr-BE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BE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BSO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r>
                        <a:rPr lang="fr-BE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BE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BSO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6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0.004</a:t>
                      </a:r>
                      <a:endParaRPr lang="fr-BE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7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1 ±</a:t>
                      </a:r>
                      <a:r>
                        <a:rPr lang="fr-BE" sz="90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0.0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1 ± 0.000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2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3 ± 0.000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6611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00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475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,512 ± 0.96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223 ± 0.05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95 ± 0.07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93 (n = 1)</a:t>
                      </a:r>
                      <a:endParaRPr lang="fr-BE" sz="900" kern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71 ± 0.04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4731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adder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9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41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27 ± 0.00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18 ± 0.035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59 ± 0.02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7 ±</a:t>
                      </a:r>
                      <a:r>
                        <a:rPr lang="fr-BE" sz="90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0.02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6 ± 0.00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4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03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6 ± 0.00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2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0 ± 0.00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8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1 ± 0.00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6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78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81 ± 0.05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82 ± 0.059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83 ± 0.03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1 ± 0.01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5 ± 0.00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5905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9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28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82 ± 0.029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4 ± 0.00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1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2 ± 0.00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1 ± 0.00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l </a:t>
                      </a: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adder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7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22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8 ± 0.00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3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3 ± 0.00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0 ± 0.009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8 ± 0.00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3974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omach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6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3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259 ± 0.07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56 ± 0.02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64 ± 0.03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4 ± 0.01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3 ± 0,01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reas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5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108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261 ± 0.08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28 ± 0,019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12 ± 0.025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5 ± 0.01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7 ± 0.005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intestin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7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29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09 ± 0.02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60 ± 0.00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56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4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0 ± 0.00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n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8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79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319 ± 0.04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258 ± 0.089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201 ± 0.03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70 ± 0.015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83 ± 0,01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ecum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2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62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78 ± 0.05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100 ± 0.03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93 ± 0.00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9</a:t>
                      </a:r>
                      <a:r>
                        <a:rPr lang="fr-BE" sz="900" kern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 0.01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3 ± 0.015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6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12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77 ± 0.01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1 ± 0.01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0 ± 0.00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0 ± 0.01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4 ± 0.008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erus</a:t>
                      </a: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ary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3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35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79 ± 0.02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5 ± 0.01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2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8 ± 0.00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2 ± 0.010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38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358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,484 ± 0.60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717 ± 0.349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735 ± 0.14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557 ± 0.18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688 ± 0.11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l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03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7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2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1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2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2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ne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6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26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96 ± 0.015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75 ± 0.04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56 ± 0.01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37 ± 0.01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0 ± 0.01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in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4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25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70 ± 0.013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4 ± 0.00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41 ± 0.007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1 ± 0.00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29 ± 0.004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76"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</a:pPr>
                      <a:r>
                        <a:rPr lang="fr-BE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  <a:endParaRPr lang="fr-B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 </a:t>
                      </a:r>
                      <a:r>
                        <a:rPr lang="fr-BE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01</a:t>
                      </a:r>
                      <a:endParaRPr lang="fr-BE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 fontAlgn="b">
                        <a:lnSpc>
                          <a:spcPct val="100000"/>
                        </a:lnSpc>
                      </a:pPr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6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10 ± 0.006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9 ± 0.002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2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,003 ± 0.001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424118" y="5771704"/>
            <a:ext cx="80403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Biodistribution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of 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u-DOTATATE at 24, 72 and 168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.i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in EJM xenograft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ice. Mice of both groups were intravenously injected with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MBq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u-DOTATATE on day 0. Mice in the combination group (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u-DOTATATE + BSO) additionally received 10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BSO via drinking water, starting on day -1. Results are expressed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s the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ean of the % injected activity per gram of tissue (%IA/g) ± SD of 4 mice per group.</a:t>
            </a:r>
            <a:endParaRPr lang="fr-BE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fr-B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7924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881489" y="4389958"/>
            <a:ext cx="372406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Water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intake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in the 4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groups. Water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consumption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monitored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every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2 to 3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the first 7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of BSO administration via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drinking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water in 10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per group.</a:t>
            </a:r>
            <a:r>
              <a:rPr lang="fr-BE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± 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EM 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of water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intake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in 2 cages (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containing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5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) per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group.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1345" y="545834"/>
            <a:ext cx="3659987" cy="3901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9958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65</TotalTime>
  <Words>447</Words>
  <Application>Microsoft Office PowerPoint</Application>
  <PresentationFormat>Grand écran</PresentationFormat>
  <Paragraphs>148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lbart Wendy</dc:creator>
  <cp:lastModifiedBy>Delbart Wendy</cp:lastModifiedBy>
  <cp:revision>826</cp:revision>
  <dcterms:created xsi:type="dcterms:W3CDTF">2020-04-06T13:23:03Z</dcterms:created>
  <dcterms:modified xsi:type="dcterms:W3CDTF">2023-03-03T08:06:26Z</dcterms:modified>
</cp:coreProperties>
</file>